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69" d="100"/>
          <a:sy n="69" d="100"/>
        </p:scale>
        <p:origin x="-1452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x-none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B7B776-1B2B-DB4B-B584-52E32DCE9F2B}" type="datetimeFigureOut">
              <a:rPr lang="en-US" smtClean="0"/>
              <a:t>3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16B589-95D5-534A-9820-2F8EE4C97A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13721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B7B776-1B2B-DB4B-B584-52E32DCE9F2B}" type="datetimeFigureOut">
              <a:rPr lang="en-US" smtClean="0"/>
              <a:t>3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16B589-95D5-534A-9820-2F8EE4C97A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02718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B7B776-1B2B-DB4B-B584-52E32DCE9F2B}" type="datetimeFigureOut">
              <a:rPr lang="en-US" smtClean="0"/>
              <a:t>3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16B589-95D5-534A-9820-2F8EE4C97A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3793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B7B776-1B2B-DB4B-B584-52E32DCE9F2B}" type="datetimeFigureOut">
              <a:rPr lang="en-US" smtClean="0"/>
              <a:t>3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16B589-95D5-534A-9820-2F8EE4C97A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88499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B7B776-1B2B-DB4B-B584-52E32DCE9F2B}" type="datetimeFigureOut">
              <a:rPr lang="en-US" smtClean="0"/>
              <a:t>3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16B589-95D5-534A-9820-2F8EE4C97A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59060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B7B776-1B2B-DB4B-B584-52E32DCE9F2B}" type="datetimeFigureOut">
              <a:rPr lang="en-US" smtClean="0"/>
              <a:t>3/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16B589-95D5-534A-9820-2F8EE4C97A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4608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B7B776-1B2B-DB4B-B584-52E32DCE9F2B}" type="datetimeFigureOut">
              <a:rPr lang="en-US" smtClean="0"/>
              <a:t>3/8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16B589-95D5-534A-9820-2F8EE4C97A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88725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B7B776-1B2B-DB4B-B584-52E32DCE9F2B}" type="datetimeFigureOut">
              <a:rPr lang="en-US" smtClean="0"/>
              <a:t>3/8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16B589-95D5-534A-9820-2F8EE4C97A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65138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B7B776-1B2B-DB4B-B584-52E32DCE9F2B}" type="datetimeFigureOut">
              <a:rPr lang="en-US" smtClean="0"/>
              <a:t>3/8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16B589-95D5-534A-9820-2F8EE4C97A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52382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B7B776-1B2B-DB4B-B584-52E32DCE9F2B}" type="datetimeFigureOut">
              <a:rPr lang="en-US" smtClean="0"/>
              <a:t>3/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16B589-95D5-534A-9820-2F8EE4C97A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03258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B7B776-1B2B-DB4B-B584-52E32DCE9F2B}" type="datetimeFigureOut">
              <a:rPr lang="en-US" smtClean="0"/>
              <a:t>3/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16B589-95D5-534A-9820-2F8EE4C97A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41472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B7B776-1B2B-DB4B-B584-52E32DCE9F2B}" type="datetimeFigureOut">
              <a:rPr lang="en-US" smtClean="0"/>
              <a:t>3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16B589-95D5-534A-9820-2F8EE4C97A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45481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1027288" y="6025782"/>
            <a:ext cx="6903156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Figure S7</a:t>
            </a:r>
            <a:r>
              <a:rPr lang="en-US" sz="1000" dirty="0">
                <a:latin typeface="Arial"/>
                <a:cs typeface="Arial"/>
              </a:rPr>
              <a:t>   Chromosome wide distribution of crossover counts for wild type (green) and </a:t>
            </a:r>
            <a:r>
              <a:rPr lang="en-US" sz="1000" i="1" dirty="0">
                <a:latin typeface="Arial"/>
                <a:cs typeface="Arial"/>
              </a:rPr>
              <a:t>mlh3</a:t>
            </a:r>
            <a:r>
              <a:rPr lang="en-US" sz="1000" i="1" dirty="0">
                <a:latin typeface="Arial"/>
                <a:cs typeface="Arial"/>
                <a:sym typeface="Symbol"/>
              </a:rPr>
              <a:t></a:t>
            </a:r>
            <a:r>
              <a:rPr lang="en-US" sz="1000" i="1" dirty="0">
                <a:latin typeface="Arial"/>
                <a:cs typeface="Arial"/>
              </a:rPr>
              <a:t> pch2</a:t>
            </a:r>
            <a:r>
              <a:rPr lang="en-US" sz="1000" i="1" dirty="0">
                <a:latin typeface="Arial"/>
                <a:cs typeface="Arial"/>
                <a:sym typeface="Symbol"/>
              </a:rPr>
              <a:t></a:t>
            </a:r>
            <a:r>
              <a:rPr lang="en-US" sz="1000" dirty="0">
                <a:latin typeface="Arial"/>
                <a:cs typeface="Arial"/>
              </a:rPr>
              <a:t> (red).  Actual crossover counts were divided by the number of tetrads to get normalized counts.  Chromosome size is shown in base pairs.  Oval circle shows position of the </a:t>
            </a:r>
            <a:r>
              <a:rPr lang="en-US" sz="1000" dirty="0" err="1">
                <a:latin typeface="Arial"/>
                <a:cs typeface="Arial"/>
              </a:rPr>
              <a:t>rDNA</a:t>
            </a:r>
            <a:r>
              <a:rPr lang="en-US" sz="1000" dirty="0">
                <a:latin typeface="Arial"/>
                <a:cs typeface="Arial"/>
              </a:rPr>
              <a:t> locus.</a:t>
            </a:r>
          </a:p>
        </p:txBody>
      </p:sp>
      <p:pic>
        <p:nvPicPr>
          <p:cNvPr id="1026" name="Picture 2" descr="C:\Users\Nishant KT\Desktop\G3_March 7\Supplementary Figures_edited\newCodit\mlh3 pch2.CO_distribution_circle.05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92275" y="522425"/>
            <a:ext cx="5757863" cy="53975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978955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54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jith V P</dc:creator>
  <cp:lastModifiedBy>Nishant KT</cp:lastModifiedBy>
  <cp:revision>3</cp:revision>
  <dcterms:created xsi:type="dcterms:W3CDTF">2017-03-07T07:30:01Z</dcterms:created>
  <dcterms:modified xsi:type="dcterms:W3CDTF">2017-03-08T06:05:12Z</dcterms:modified>
</cp:coreProperties>
</file>